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88" r:id="rId3"/>
    <p:sldId id="266" r:id="rId4"/>
    <p:sldId id="290" r:id="rId5"/>
    <p:sldId id="291" r:id="rId6"/>
    <p:sldId id="280" r:id="rId7"/>
    <p:sldId id="281" r:id="rId8"/>
    <p:sldId id="269" r:id="rId9"/>
    <p:sldId id="283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8" d="100"/>
          <a:sy n="78" d="100"/>
        </p:scale>
        <p:origin x="-114" y="-6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6032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1738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9891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9048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425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7443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159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0572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2807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637069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0625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C9F19-B09B-4A2D-AD36-09A7721ACD36}" type="datetimeFigureOut">
              <a:rPr lang="zh-CN" altLang="en-US" smtClean="0"/>
              <a:t>2017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9C3B1F-6D9E-4537-B4D6-15C2F542D89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6024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90152" y="51514"/>
            <a:ext cx="347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1</a:t>
            </a:r>
            <a:endParaRPr lang="zh-CN" altLang="en-US" b="1" dirty="0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1319" y="1023120"/>
            <a:ext cx="6791014" cy="4735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941408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6017"/>
            <a:ext cx="11953461" cy="675198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-1910" y="-73727"/>
            <a:ext cx="28352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2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308467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9701" y="566670"/>
            <a:ext cx="11522299" cy="639828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77602" y="106952"/>
            <a:ext cx="2498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3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883626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5343" y="709952"/>
            <a:ext cx="5949108" cy="4749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7602" y="106952"/>
            <a:ext cx="2498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4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8595323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9769" y="1023617"/>
            <a:ext cx="6663313" cy="429535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7602" y="106952"/>
            <a:ext cx="2498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5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8325901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460" y="1001395"/>
            <a:ext cx="6147320" cy="549009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886845" y="5804382"/>
            <a:ext cx="1159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/>
              <a:t>trehalose</a:t>
            </a:r>
            <a:endParaRPr lang="zh-CN" alt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25082" y="1486578"/>
            <a:ext cx="11590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/>
              <a:t>fructose</a:t>
            </a:r>
            <a:endParaRPr lang="zh-CN" altLang="en-US" sz="12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5558803" y="4717409"/>
            <a:ext cx="1159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/>
              <a:t>raffinose</a:t>
            </a:r>
            <a:endParaRPr lang="zh-CN" alt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591342" y="5701292"/>
            <a:ext cx="1159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sucrose</a:t>
            </a:r>
            <a:endParaRPr lang="zh-CN" alt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61782" y="3507514"/>
            <a:ext cx="1159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/>
              <a:t>cellobiose</a:t>
            </a:r>
            <a:endParaRPr lang="zh-CN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157639" y="4906058"/>
            <a:ext cx="11590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agatose</a:t>
            </a:r>
            <a:endParaRPr lang="zh-CN" alt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34685" y="746769"/>
            <a:ext cx="626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A</a:t>
            </a:r>
            <a:endParaRPr lang="zh-CN" altLang="en-US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468763" y="772750"/>
            <a:ext cx="3838095" cy="5666667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256828" y="757500"/>
            <a:ext cx="626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66032" y="99042"/>
            <a:ext cx="24981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Figure </a:t>
            </a:r>
            <a:r>
              <a:rPr lang="en-US" altLang="zh-CN" b="1" dirty="0" smtClean="0"/>
              <a:t>S6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741820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2166577"/>
              </p:ext>
            </p:extLst>
          </p:nvPr>
        </p:nvGraphicFramePr>
        <p:xfrm>
          <a:off x="2446988" y="132887"/>
          <a:ext cx="9285668" cy="6634740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605912"/>
                <a:gridCol w="2528116"/>
                <a:gridCol w="2575820"/>
                <a:gridCol w="2575820"/>
              </a:tblGrid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Gene nam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Forwad primer（5'-3'）</a:t>
                      </a:r>
                      <a:endParaRPr lang="en-US" sz="14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Reverse primer(5'-3'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functio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Nt26S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AAGAAGGTCCCAAGGGT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TCCCTTTAACACCAAC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Internal control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44821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GAGAGATGTTATCGGCA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AAAGGGACAGTGGGAG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MY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64865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TTCGTGGGGTTAGGCAG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TCAAAGCATCAGGACCA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RF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8380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TCCAAAGCCTCAGTCCA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AATGTCCTCGTCGCCAA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WRKY3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9563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ATCCAAAGAAACGTGCG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CCATTTCTGCAGTTGGG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REB1D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9891_g2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CAAGAAGGGCAGCTAGA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GCTGTGTTAGTTCCCTG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ERF109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59823_g2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AGGGAAGTTGAACGGC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GGGCAATGCACTTTA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unknow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63831_g1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CGACCTTGGAAATGTTG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TCCAACAGATTCCGGCAA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ELF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64765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AGAAGAGAACGCGGCAA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ATCCCAGCTGAAACAAC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REB1F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67085_g1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GAGGAAGGGGCTGAAGA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GGCATTGGTTGTGTCGA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RR6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0415_g4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CCCTTCACCATTTTCCG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GCTTCTCTGATTCGAGC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NFYB7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0702_g2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GCATTAGTCCTTCCGCC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ATCCCAGCTTCTACCGAC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REB1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0842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GGTCTGGTGAGGGTAAT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GCTCTTCTTTCACGACG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OR41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1056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AGAAGGCGCAATGGAT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ACCCACTTTCCCCATGT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REB2H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1107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GCCGATACATTTCCATAGC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TTTCCCAGCAAGCCAT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BHLH92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2839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TCTCCCCATCACCGTCA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TGCCCCAACAAGTAGCAA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RR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3886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TTGAAGTCTTCCTGCCGT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ACTCCACTGGATACCTC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DREB2A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74180_g1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AGGTGCAACTTCCAGG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TTCGTTCACTGCCTCA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GAI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4525_g2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GAGGGTGGATAATGGCT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CTCTCCTTCATATCCCC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BR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75413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CGTACCTAACCAAACCCG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GTCGCCGGAAAGTCTT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RAV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77215_g2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CAACGTGGTGAGCGATA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ATTCCTCGGCCAATAGT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unkown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81375_g1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GCGGACATGACAACTA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TCCATATCACGCGTTG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ERF05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81815_g3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GAGGGGCCTTCTTCTTCT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CCATTCCAATCATCGGC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RR1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85046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AATTTTGCGATGGAGGC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CGATATTGATCCCTGGCC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CMTA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85178_g2_1</a:t>
                      </a:r>
                      <a:endParaRPr lang="en-US" sz="14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TTTGGCCATGACTGCTG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CACTAGACGGCAATCAC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HK3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85784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ACACCAGTGAAGACGAGGA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AAGCCACATCCAGCAAAAGG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HOS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85969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GAAGCTGGCAAGTTGGA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CGAATTGCCGACCAGATT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HK4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86033_g1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GCTGCTGTGATTGCCTAGA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TCCTGACCAGTTCTTGCCAT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ARR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  <a:tr h="168409"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86950_g3_1</a:t>
                      </a:r>
                      <a:endParaRPr lang="en-US" sz="1400" b="0" i="1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>
                          <a:effectLst/>
                          <a:latin typeface="+mn-lt"/>
                        </a:rPr>
                        <a:t>CTTCTCCACAACTTCGCAGC</a:t>
                      </a:r>
                      <a:endParaRPr lang="en-US" sz="14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u="none" strike="noStrike" dirty="0">
                          <a:effectLst/>
                          <a:latin typeface="+mn-lt"/>
                        </a:rPr>
                        <a:t>CTAGATGTTTCCGCCAGCAT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  <a:ea typeface="宋体" panose="02010600030101010101" pitchFamily="2" charset="-122"/>
                        </a:rPr>
                        <a:t>SIZ1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ea typeface="宋体" panose="02010600030101010101" pitchFamily="2" charset="-122"/>
                      </a:endParaRPr>
                    </a:p>
                  </a:txBody>
                  <a:tcPr marL="7798" marR="7798" marT="7798" marB="0" anchor="b"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5758" y="132887"/>
            <a:ext cx="347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Table </a:t>
            </a:r>
            <a:r>
              <a:rPr lang="en-US" altLang="zh-CN" b="1" dirty="0" smtClean="0"/>
              <a:t>S1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577591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9580290"/>
              </p:ext>
            </p:extLst>
          </p:nvPr>
        </p:nvGraphicFramePr>
        <p:xfrm>
          <a:off x="819996" y="889569"/>
          <a:ext cx="10552048" cy="5345764"/>
        </p:xfrm>
        <a:graphic>
          <a:graphicData uri="http://schemas.openxmlformats.org/drawingml/2006/table">
            <a:tbl>
              <a:tblPr>
                <a:tableStyleId>{85BE263C-DBD7-4A20-BB59-AAB30ACAA65A}</a:tableStyleId>
              </a:tblPr>
              <a:tblGrid>
                <a:gridCol w="1083897"/>
                <a:gridCol w="860741"/>
                <a:gridCol w="860741"/>
                <a:gridCol w="860741"/>
                <a:gridCol w="860741"/>
                <a:gridCol w="860741"/>
                <a:gridCol w="860741"/>
                <a:gridCol w="860741"/>
                <a:gridCol w="860741"/>
                <a:gridCol w="860741"/>
                <a:gridCol w="860741"/>
                <a:gridCol w="860741"/>
              </a:tblGrid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err="1">
                          <a:effectLst/>
                        </a:rPr>
                        <a:t>gene_id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C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C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T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T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KC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KC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KT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KT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FC(CB-1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FC(K326)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Name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278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0842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14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20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86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35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78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14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95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23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43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12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effectLst/>
                        </a:rPr>
                        <a:t>COR41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030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81086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9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17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7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2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21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1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23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33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63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78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effectLst/>
                        </a:rPr>
                        <a:t>COR413I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21499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3381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32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93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52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75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46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33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47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71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51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19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 smtClean="0">
                          <a:effectLst/>
                        </a:rPr>
                        <a:t>COR413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9563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83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17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39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6.51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79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6.46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2.30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37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64765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2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39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38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6.00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70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5.69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F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67621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1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3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36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48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52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7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32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F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9563_g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04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3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20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71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42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58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63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14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B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3886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7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26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34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15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62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25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2A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1056_g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19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21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58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84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70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21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2H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80221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96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35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48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2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01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17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71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00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4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D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24612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58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5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18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2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59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F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59493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31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7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42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37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25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01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79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63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59493_g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3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91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8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28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23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0.97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46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0702_g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5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89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64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29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42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6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1B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0895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95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4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33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4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9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9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2A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52393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17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32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54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53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79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84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16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2H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67134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60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1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43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71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12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32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49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75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64231_g2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55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15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26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2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02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49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97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51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1.773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1296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32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66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7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054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4.085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26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43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1.808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2.23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-2.052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DREB3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  <a:tr h="19925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>
                          <a:effectLst/>
                        </a:rPr>
                        <a:t>c74172_g1</a:t>
                      </a:r>
                      <a:endParaRPr lang="en-US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606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317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 dirty="0">
                          <a:effectLst/>
                        </a:rPr>
                        <a:t>0.000 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0.00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93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329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2.961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u="none" strike="noStrike">
                          <a:effectLst/>
                        </a:rPr>
                        <a:t>3.130 </a:t>
                      </a:r>
                      <a:endParaRPr lang="en-US" altLang="zh-CN" sz="16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effectLst/>
                        </a:rPr>
                        <a:t>DREB2C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9525" marR="9525" marT="9525" marB="0" anchor="ctr"/>
                </a:tc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141667" y="218939"/>
            <a:ext cx="347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/>
              <a:t>Table </a:t>
            </a:r>
            <a:r>
              <a:rPr lang="en-US" altLang="zh-CN" b="1" dirty="0" smtClean="0"/>
              <a:t>S2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42059775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0225611"/>
              </p:ext>
            </p:extLst>
          </p:nvPr>
        </p:nvGraphicFramePr>
        <p:xfrm>
          <a:off x="360611" y="1170428"/>
          <a:ext cx="11281893" cy="39319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11699"/>
                <a:gridCol w="1611699"/>
                <a:gridCol w="1611699"/>
                <a:gridCol w="1611699"/>
                <a:gridCol w="1611699"/>
                <a:gridCol w="1611699"/>
                <a:gridCol w="1611699"/>
              </a:tblGrid>
              <a:tr h="297764">
                <a:tc rowSpan="2">
                  <a:txBody>
                    <a:bodyPr/>
                    <a:lstStyle/>
                    <a:p>
                      <a:pPr algn="ctr"/>
                      <a:endParaRPr lang="en-US" altLang="zh-CN" dirty="0" smtClean="0"/>
                    </a:p>
                    <a:p>
                      <a:pPr algn="ctr"/>
                      <a:r>
                        <a:rPr lang="en-US" altLang="zh-CN" dirty="0" smtClean="0"/>
                        <a:t>family</a:t>
                      </a:r>
                      <a:endParaRPr lang="zh-CN" alt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K326</a:t>
                      </a:r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CB-1</a:t>
                      </a:r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</a:tr>
              <a:tr h="472916">
                <a:tc vMerge="1">
                  <a:txBody>
                    <a:bodyPr/>
                    <a:lstStyle/>
                    <a:p>
                      <a:pPr algn="ctr"/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Up-regulatio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Down-regulatio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No change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Up-regulatio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Down-regulatio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No change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ERF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3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8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6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ABR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EIN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3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CRF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AIL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ANT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2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RAP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1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4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dirty="0" smtClean="0"/>
                        <a:t>13</a:t>
                      </a:r>
                      <a:endParaRPr lang="zh-CN" altLang="en-US" dirty="0"/>
                    </a:p>
                  </a:txBody>
                  <a:tcPr/>
                </a:tc>
              </a:tr>
              <a:tr h="325646"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SUM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44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9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53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27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8</a:t>
                      </a:r>
                      <a:endParaRPr lang="zh-CN" altLang="en-US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b="1" dirty="0" smtClean="0"/>
                        <a:t>71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41667" y="103028"/>
            <a:ext cx="347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smtClean="0"/>
              <a:t>Table </a:t>
            </a:r>
            <a:r>
              <a:rPr lang="en-US" altLang="zh-CN" b="1" dirty="0" smtClean="0"/>
              <a:t>S3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23344096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13</TotalTime>
  <Words>492</Words>
  <Application>Microsoft Office PowerPoint</Application>
  <PresentationFormat>Custom</PresentationFormat>
  <Paragraphs>455</Paragraphs>
  <Slides>9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jing</dc:creator>
  <cp:lastModifiedBy>Abella, Jerard Dave</cp:lastModifiedBy>
  <cp:revision>236</cp:revision>
  <dcterms:created xsi:type="dcterms:W3CDTF">2017-01-03T06:59:56Z</dcterms:created>
  <dcterms:modified xsi:type="dcterms:W3CDTF">2017-06-20T22:17:59Z</dcterms:modified>
</cp:coreProperties>
</file>